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2" r:id="rId2"/>
    <p:sldId id="269" r:id="rId3"/>
    <p:sldId id="267" r:id="rId4"/>
    <p:sldId id="270" r:id="rId5"/>
    <p:sldId id="261" r:id="rId6"/>
    <p:sldId id="268" r:id="rId7"/>
    <p:sldId id="283" r:id="rId8"/>
  </p:sldIdLst>
  <p:sldSz cx="12192000" cy="6858000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6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93" autoAdjust="0"/>
    <p:restoredTop sz="93987" autoAdjust="0"/>
  </p:normalViewPr>
  <p:slideViewPr>
    <p:cSldViewPr snapToGrid="0" showGuides="1">
      <p:cViewPr>
        <p:scale>
          <a:sx n="80" d="100"/>
          <a:sy n="80" d="100"/>
        </p:scale>
        <p:origin x="3192" y="1608"/>
      </p:cViewPr>
      <p:guideLst>
        <p:guide orient="horz" pos="286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458536E-C762-4060-8BDA-7FB34A53B713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3013"/>
            <a:ext cx="596265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7BE057-B656-4E59-866B-A54C135CEA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13365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https://store.aamc.org/downloadable/download/sample/sample_id/174/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7BE057-B656-4E59-866B-A54C135CEAC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621406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zh-TW" dirty="0"/>
              <a:t>JPN-MHLW</a:t>
            </a:r>
          </a:p>
          <a:p>
            <a:r>
              <a:rPr kumimoji="1" lang="zh-TW" altLang="en-US" dirty="0"/>
              <a:t>臨床研修到達目標</a:t>
            </a:r>
            <a:r>
              <a:rPr kumimoji="1" lang="en-US" altLang="zh-TW" dirty="0"/>
              <a:t>2020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AD483F3-46AE-4DAA-9CAE-D3061DB2DB4F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43606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zh-TW" dirty="0"/>
              <a:t>JPN-MHLW</a:t>
            </a:r>
          </a:p>
          <a:p>
            <a:r>
              <a:rPr kumimoji="1" lang="zh-TW" altLang="en-US" dirty="0"/>
              <a:t>臨床研修到達目標</a:t>
            </a:r>
            <a:r>
              <a:rPr kumimoji="1" lang="en-US" altLang="zh-TW" dirty="0"/>
              <a:t>2020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AD483F3-46AE-4DAA-9CAE-D3061DB2DB4F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84252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AC53984-9039-44FB-9E99-B1EB4DDAA3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7D15E4C-3D25-4357-818D-62A41F7E87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5738FCA-F808-4535-B7CD-1A6D2A4C3E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07407-74EB-45D9-8F2E-9E8E2D92B1BB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3E8401D-B581-4144-BCA1-44304EAC1B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3F8C5C7-000D-4B5B-A0C3-8D77813C1E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3DD54-E070-4E16-85DC-868356C7B6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4254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87A5BED-09DA-47B6-96E5-4A56817569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CCC6DCB-12E5-4F96-B18B-6BD8D652F5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FA308CF-C4BC-4C9C-BAF2-E0B1C317E5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07407-74EB-45D9-8F2E-9E8E2D92B1BB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C1FD810-014C-436F-92D8-D4D3056132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D89CCD2-71D5-4AD9-B0CE-2D9A60BFB6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3DD54-E070-4E16-85DC-868356C7B6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3276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A6184FB-95F2-4AB8-B115-A61468512B4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50741CD-566A-452D-8132-561063759C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8C73483-B5AE-43FC-8434-F0F3007BC3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07407-74EB-45D9-8F2E-9E8E2D92B1BB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FF50C08-D7B8-44A7-9196-C054900566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059AC1E-E5C3-4B42-842F-7AED8277AB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3DD54-E070-4E16-85DC-868356C7B6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1638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662EFEF-C252-44F3-9E4D-12F3C900B9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C88B936-7058-493F-B03C-C015AB5BEB5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695F664-C062-4730-BBC4-E09D2ABDE6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07407-74EB-45D9-8F2E-9E8E2D92B1BB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EE7140A-D11F-41DD-9618-9C97218865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03F8A8A-90CD-4D78-BD00-ECBE2A6304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3DD54-E070-4E16-85DC-868356C7B6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19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643255-6151-4696-8DF6-B7B688093E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A0FA3CD-AD4D-4731-80B5-E7E6FB0DD2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EDB34AB-F73E-4DCC-895E-B987E11A8B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07407-74EB-45D9-8F2E-9E8E2D92B1BB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2743AC-D5A4-4215-B1DF-5D4A81F672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701E3DA-95A3-467E-B239-6DB5158ABC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3DD54-E070-4E16-85DC-868356C7B6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21950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266CEDB-9D50-41D3-ADB8-E4F9248C91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8A164F4-FADB-4F31-BF95-E03FE1D7A4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BDF8DC8-61D7-4824-B2E4-F504CAD635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07A7268-C037-41B6-9EFB-C089DD717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07407-74EB-45D9-8F2E-9E8E2D92B1BB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BF86B60-B4D5-4BEC-AC1B-9ABC00A521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FA3CA66-FA23-4532-B05B-837239DC11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3DD54-E070-4E16-85DC-868356C7B6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8417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92470E8-7F06-4176-8AEA-99147FACE8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705E381-0ABE-42BA-BB9E-224D628650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6D6CC30-C0EB-4F1A-B05F-587ADF52CE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AED3DD8-5424-445A-BC37-59EA954D57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366E8EF-4A91-4A7E-8D3B-96DD210A95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38CC843-2CE9-4DA0-A518-164FB7D5CB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07407-74EB-45D9-8F2E-9E8E2D92B1BB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884BC92-60D0-4A70-A554-A1F437BC3B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7250722-7D06-4777-9003-56BE25AB58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3DD54-E070-4E16-85DC-868356C7B6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07320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7AA24BF-9AEE-41EC-BC04-571E47EE9E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50FC367-5283-488C-BD82-D9DB1D02E5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07407-74EB-45D9-8F2E-9E8E2D92B1BB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5B71E63-B41B-4573-8EC9-702756E34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8C3C0EA-8088-4018-9FAA-C9CE686AC4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3DD54-E070-4E16-85DC-868356C7B6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54080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D2C26DB-6301-4C6C-A7E4-6D1ADE7362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07407-74EB-45D9-8F2E-9E8E2D92B1BB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6B38716-26BE-4C5A-8614-96FFEC2099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0887D66-4B59-4AA4-8AB9-86F64DADED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3DD54-E070-4E16-85DC-868356C7B6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8067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AB68C67-2D6A-4071-ADCF-6D1B6E64C5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F365B11-172E-42A4-9EC1-48801927AD3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3D03754-907F-4144-8BD6-D9B342F446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630B3D4-3F6A-44BF-A332-E9AC20AD15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07407-74EB-45D9-8F2E-9E8E2D92B1BB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2F09D13-1D51-4B5A-A263-D88C2F295D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4D48AC4-9CA0-445E-BF8F-78EFA59F00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3DD54-E070-4E16-85DC-868356C7B6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6743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949BDF8-1292-46B8-8BAB-E1AE840701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AEECF6B-5C0A-42D3-B0E8-496D60BA465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A5BA01E-ED1D-4E68-AA7F-A1CDBBB2C6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888F177-D42F-4ED9-B978-CFE6ED7353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07407-74EB-45D9-8F2E-9E8E2D92B1BB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FBC0EE7-3A43-49D4-A4FC-599F427672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292B825-E4B0-4754-A709-38A54D3C73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3DD54-E070-4E16-85DC-868356C7B6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2361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73D34ED-F8FE-48F1-8B76-8AFCD08018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D501D99-A342-47F3-AA84-8ED5C81640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EEB3531-1988-4AF0-A8E6-EB3FB4C68BE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607407-74EB-45D9-8F2E-9E8E2D92B1BB}" type="datetimeFigureOut">
              <a:rPr kumimoji="1" lang="ja-JP" altLang="en-US" smtClean="0"/>
              <a:t>2022/9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AAE7211-C6CA-4DFA-BF08-B18C9548A4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EF5276-FB60-44E2-82BB-B74C8B7594E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93DD54-E070-4E16-85DC-868356C7B6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4277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stfm.org/media/1363/clinicalskills_oct09qxdpdf.pdf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gmc-uk.org/ethical-guidance/ethical-guidance-for-doctors/good-medical-practice/duties-of-a-doctor" TargetMode="Externa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gmc-uk.org/-/media/documents/dc11326-outcomes-for-graduates-2018_pdf-75040796.pdf" TargetMode="Externa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gmc-uk.org/-/media/documents/practical-skills-and-procedures-a4_pdf-78058950.pdf" TargetMode="Externa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mext.go.jp/component/a_menu/education/detail/__icsFiles/afieldfile/2018/06/18/1325989_30.pdf" TargetMode="Externa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mhlw.go.jp/content/10800000/000719078.pdf" TargetMode="Externa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hyperlink" Target="https://mededpublish.org/articles/8-91" TargetMode="Externa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FBEB507-D47D-4372-82E9-B059B3D5EA99}"/>
              </a:ext>
            </a:extLst>
          </p:cNvPr>
          <p:cNvSpPr txBox="1"/>
          <p:nvPr/>
        </p:nvSpPr>
        <p:spPr>
          <a:xfrm>
            <a:off x="24466" y="0"/>
            <a:ext cx="1214306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upplementary 1. Recommendations for Clinical Skills Curricula for Undergraduate Medical Education [43]</a:t>
            </a:r>
            <a:endParaRPr lang="ja-JP" altLang="ja-JP" dirty="0"/>
          </a:p>
          <a:p>
            <a:r>
              <a:rPr lang="en-US" altLang="ja-JP" u="sng" dirty="0">
                <a:hlinkClick r:id="rId3"/>
              </a:rPr>
              <a:t>https://www.stfm.org/media/1363/clinicalskills_oct09qxdpdf.pdf</a:t>
            </a:r>
            <a:r>
              <a:rPr lang="en-US" altLang="ja-JP" dirty="0"/>
              <a:t> </a:t>
            </a:r>
            <a:endParaRPr lang="ja-JP" altLang="ja-JP" dirty="0"/>
          </a:p>
        </p:txBody>
      </p:sp>
      <p:graphicFrame>
        <p:nvGraphicFramePr>
          <p:cNvPr id="9" name="表 8">
            <a:extLst>
              <a:ext uri="{FF2B5EF4-FFF2-40B4-BE49-F238E27FC236}">
                <a16:creationId xmlns:a16="http://schemas.microsoft.com/office/drawing/2014/main" id="{74F741F2-5D37-4263-9EBA-3B295D60782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4935093"/>
              </p:ext>
            </p:extLst>
          </p:nvPr>
        </p:nvGraphicFramePr>
        <p:xfrm>
          <a:off x="360946" y="738104"/>
          <a:ext cx="11500677" cy="593172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88170">
                  <a:extLst>
                    <a:ext uri="{9D8B030D-6E8A-4147-A177-3AD203B41FA5}">
                      <a16:colId xmlns:a16="http://schemas.microsoft.com/office/drawing/2014/main" val="3585613830"/>
                    </a:ext>
                  </a:extLst>
                </a:gridCol>
                <a:gridCol w="469231">
                  <a:extLst>
                    <a:ext uri="{9D8B030D-6E8A-4147-A177-3AD203B41FA5}">
                      <a16:colId xmlns:a16="http://schemas.microsoft.com/office/drawing/2014/main" val="1595770788"/>
                    </a:ext>
                  </a:extLst>
                </a:gridCol>
                <a:gridCol w="2574758">
                  <a:extLst>
                    <a:ext uri="{9D8B030D-6E8A-4147-A177-3AD203B41FA5}">
                      <a16:colId xmlns:a16="http://schemas.microsoft.com/office/drawing/2014/main" val="2125297549"/>
                    </a:ext>
                  </a:extLst>
                </a:gridCol>
                <a:gridCol w="2153653">
                  <a:extLst>
                    <a:ext uri="{9D8B030D-6E8A-4147-A177-3AD203B41FA5}">
                      <a16:colId xmlns:a16="http://schemas.microsoft.com/office/drawing/2014/main" val="4039397419"/>
                    </a:ext>
                  </a:extLst>
                </a:gridCol>
                <a:gridCol w="397042">
                  <a:extLst>
                    <a:ext uri="{9D8B030D-6E8A-4147-A177-3AD203B41FA5}">
                      <a16:colId xmlns:a16="http://schemas.microsoft.com/office/drawing/2014/main" val="1124061760"/>
                    </a:ext>
                  </a:extLst>
                </a:gridCol>
                <a:gridCol w="4317823">
                  <a:extLst>
                    <a:ext uri="{9D8B030D-6E8A-4147-A177-3AD203B41FA5}">
                      <a16:colId xmlns:a16="http://schemas.microsoft.com/office/drawing/2014/main" val="364246612"/>
                    </a:ext>
                  </a:extLst>
                </a:gridCol>
              </a:tblGrid>
              <a:tr h="557776">
                <a:tc grid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ommendations for Clinical Skills Curricula for Undergraduate Medical Education</a:t>
                      </a:r>
                      <a:r>
                        <a:rPr lang="en-US" altLang="ja-JP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(UME) 2005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duate Medical Education (GME) Competencies 2002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85557100"/>
                  </a:ext>
                </a:extLst>
              </a:tr>
              <a:tr h="7962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Organizer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he American Medical Association (AMA)</a:t>
                      </a:r>
                    </a:p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he Association of American Medical Colleges (AAMC)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endParaRPr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5136231"/>
                  </a:ext>
                </a:extLst>
              </a:tr>
              <a:tr h="55777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Objects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Medical Students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esidents</a:t>
                      </a:r>
                    </a:p>
                    <a:p>
                      <a:pPr algn="l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6003913"/>
                  </a:ext>
                </a:extLst>
              </a:tr>
              <a:tr h="836665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oals / Competencies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rofessionalism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→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rofessionalism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7725351"/>
                  </a:ext>
                </a:extLst>
              </a:tr>
              <a:tr h="398129"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pplication of Scientific Knowledge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→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I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edical Knowledge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5228852"/>
                  </a:ext>
                </a:extLst>
              </a:tr>
              <a:tr h="398129"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atient Engagement &amp; Communication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→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II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nterpersonal and communication Skill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3421201"/>
                  </a:ext>
                </a:extLst>
              </a:tr>
              <a:tr h="1278238"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History-taking</a:t>
                      </a:r>
                      <a:b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</a:b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Mental &amp; Physical Examination </a:t>
                      </a:r>
                    </a:p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linical Testing, </a:t>
                      </a:r>
                    </a:p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linical Procedures </a:t>
                      </a:r>
                    </a:p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nformation Management </a:t>
                      </a:r>
                    </a:p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Diagnosis Skill, </a:t>
                      </a:r>
                    </a:p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reatment, Prevention &amp; Palliation </a:t>
                      </a:r>
                    </a:p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rognosis Skill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→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IV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atient Care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1378466"/>
                  </a:ext>
                </a:extLst>
              </a:tr>
              <a:tr h="398129"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ll categories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→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Practice-based Learning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1875678"/>
                  </a:ext>
                </a:extLst>
              </a:tr>
              <a:tr h="525820"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are in Context Skills</a:t>
                      </a: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→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VI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Systems Based Practice</a:t>
                      </a:r>
                    </a:p>
                  </a:txBody>
                  <a:tcPr marL="9525" marR="9525" marT="9525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247798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282203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FBEB507-D47D-4372-82E9-B059B3D5EA99}"/>
              </a:ext>
            </a:extLst>
          </p:cNvPr>
          <p:cNvSpPr txBox="1"/>
          <p:nvPr/>
        </p:nvSpPr>
        <p:spPr>
          <a:xfrm>
            <a:off x="0" y="-12032"/>
            <a:ext cx="11280652" cy="615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upplementary 2. </a:t>
            </a:r>
            <a:r>
              <a:rPr lang="en-US" altLang="ja-JP" b="1" u="sng" dirty="0"/>
              <a:t>The duties of a doctor registered with the General Medical Council 2016, UK [44]</a:t>
            </a:r>
            <a:endParaRPr lang="ja-JP" altLang="ja-JP" dirty="0"/>
          </a:p>
          <a:p>
            <a:r>
              <a:rPr lang="en-US" altLang="ja-JP" sz="1600" u="sng" dirty="0">
                <a:hlinkClick r:id="rId2"/>
              </a:rPr>
              <a:t>https://www.gmc-uk.org/ethical-guidance/ethical-guidance-for-doctors/good-medical-practice/duties-of-a-doctor</a:t>
            </a:r>
            <a:r>
              <a:rPr lang="en-US" altLang="ja-JP" sz="1600" dirty="0"/>
              <a:t> </a:t>
            </a:r>
            <a:endParaRPr lang="ja-JP" altLang="ja-JP" sz="1600" dirty="0"/>
          </a:p>
        </p:txBody>
      </p:sp>
      <p:graphicFrame>
        <p:nvGraphicFramePr>
          <p:cNvPr id="9" name="表 8">
            <a:extLst>
              <a:ext uri="{FF2B5EF4-FFF2-40B4-BE49-F238E27FC236}">
                <a16:creationId xmlns:a16="http://schemas.microsoft.com/office/drawing/2014/main" id="{74F741F2-5D37-4263-9EBA-3B295D60782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55919477"/>
              </p:ext>
            </p:extLst>
          </p:nvPr>
        </p:nvGraphicFramePr>
        <p:xfrm>
          <a:off x="363297" y="693955"/>
          <a:ext cx="11465405" cy="606629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73108">
                  <a:extLst>
                    <a:ext uri="{9D8B030D-6E8A-4147-A177-3AD203B41FA5}">
                      <a16:colId xmlns:a16="http://schemas.microsoft.com/office/drawing/2014/main" val="3585613830"/>
                    </a:ext>
                  </a:extLst>
                </a:gridCol>
                <a:gridCol w="2560060">
                  <a:extLst>
                    <a:ext uri="{9D8B030D-6E8A-4147-A177-3AD203B41FA5}">
                      <a16:colId xmlns:a16="http://schemas.microsoft.com/office/drawing/2014/main" val="838465298"/>
                    </a:ext>
                  </a:extLst>
                </a:gridCol>
                <a:gridCol w="6932237">
                  <a:extLst>
                    <a:ext uri="{9D8B030D-6E8A-4147-A177-3AD203B41FA5}">
                      <a16:colId xmlns:a16="http://schemas.microsoft.com/office/drawing/2014/main" val="1122645958"/>
                    </a:ext>
                  </a:extLst>
                </a:gridCol>
              </a:tblGrid>
              <a:tr h="242652">
                <a:tc gridSpan="3"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</a:pPr>
                      <a:r>
                        <a:rPr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 duties of a doctor registered with the General Medical Council</a:t>
                      </a:r>
                      <a:r>
                        <a:rPr lang="ja-JP" alt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6</a:t>
                      </a:r>
                      <a:endParaRPr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85557100"/>
                  </a:ext>
                </a:extLst>
              </a:tr>
              <a:tr h="242652">
                <a:tc>
                  <a:txBody>
                    <a:bodyPr/>
                    <a:lstStyle/>
                    <a:p>
                      <a:pPr algn="l" fontAlgn="ctr">
                        <a:lnSpc>
                          <a:spcPct val="120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Organizer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ral Medical Council, UK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</a:pPr>
                      <a:endParaRPr lang="ja-JP" altLang="en-US" sz="12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5136231"/>
                  </a:ext>
                </a:extLst>
              </a:tr>
              <a:tr h="242652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Objects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edical students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20000"/>
                        </a:lnSpc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6003913"/>
                  </a:ext>
                </a:extLst>
              </a:tr>
              <a:tr h="1213258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oals / Competencies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20000"/>
                        </a:lnSpc>
                      </a:pPr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; Knowledge, skills and performanc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lnSpc>
                          <a:spcPct val="120000"/>
                        </a:lnSpc>
                        <a:buFont typeface="Arial" panose="020B0604020202020204" pitchFamily="34" charset="0"/>
                        <a:buChar char="•"/>
                      </a:pPr>
                      <a:r>
                        <a:rPr lang="en-US" altLang="ja-JP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ke the care of your patient your first concern.</a:t>
                      </a:r>
                    </a:p>
                    <a:p>
                      <a:pPr marL="171450" indent="-171450">
                        <a:lnSpc>
                          <a:spcPct val="120000"/>
                        </a:lnSpc>
                        <a:buFont typeface="Arial" panose="020B0604020202020204" pitchFamily="34" charset="0"/>
                        <a:buChar char="•"/>
                      </a:pPr>
                      <a:r>
                        <a:rPr lang="en-US" altLang="ja-JP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vide a good standard of practice and care.</a:t>
                      </a:r>
                    </a:p>
                    <a:p>
                      <a:pPr marL="171450" indent="9525">
                        <a:lnSpc>
                          <a:spcPct val="120000"/>
                        </a:lnSpc>
                        <a:buFont typeface="Wingdings" panose="05000000000000000000" pitchFamily="2" charset="2"/>
                        <a:buChar char="Ø"/>
                      </a:pPr>
                      <a:r>
                        <a:rPr lang="en-US" altLang="ja-JP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eep your professional knowledge and skills up to date.</a:t>
                      </a:r>
                    </a:p>
                    <a:p>
                      <a:pPr marL="171450" indent="9525">
                        <a:lnSpc>
                          <a:spcPct val="120000"/>
                        </a:lnSpc>
                        <a:buFont typeface="Wingdings" panose="05000000000000000000" pitchFamily="2" charset="2"/>
                        <a:buChar char="Ø"/>
                      </a:pPr>
                      <a:r>
                        <a:rPr lang="en-US" altLang="ja-JP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ognize and work within the limits of your competence.</a:t>
                      </a:r>
                    </a:p>
                    <a:p>
                      <a:pPr>
                        <a:lnSpc>
                          <a:spcPct val="120000"/>
                        </a:lnSpc>
                      </a:pPr>
                      <a:endParaRPr lang="ja-JP" altLang="en-US" sz="12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7725351"/>
                  </a:ext>
                </a:extLst>
              </a:tr>
              <a:tr h="727955">
                <a:tc>
                  <a:txBody>
                    <a:bodyPr/>
                    <a:lstStyle/>
                    <a:p>
                      <a:pPr algn="l" fontAlgn="ctr">
                        <a:lnSpc>
                          <a:spcPct val="120000"/>
                        </a:lnSpc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20000"/>
                        </a:lnSpc>
                      </a:pPr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; Safety and qualit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lnSpc>
                          <a:spcPct val="120000"/>
                        </a:lnSpc>
                        <a:buFont typeface="Arial" panose="020B0604020202020204" pitchFamily="34" charset="0"/>
                        <a:buChar char="•"/>
                      </a:pPr>
                      <a:r>
                        <a:rPr lang="en-US" altLang="ja-JP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ke prompt action if you think that patient safety, dignity or comfort is being compromised.</a:t>
                      </a:r>
                    </a:p>
                    <a:p>
                      <a:pPr marL="171450" indent="-171450">
                        <a:lnSpc>
                          <a:spcPct val="120000"/>
                        </a:lnSpc>
                        <a:buFont typeface="Arial" panose="020B0604020202020204" pitchFamily="34" charset="0"/>
                        <a:buChar char="•"/>
                      </a:pPr>
                      <a:r>
                        <a:rPr lang="en-US" altLang="ja-JP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ct and promote the health of patients and the public.</a:t>
                      </a:r>
                    </a:p>
                    <a:p>
                      <a:pPr>
                        <a:lnSpc>
                          <a:spcPct val="120000"/>
                        </a:lnSpc>
                      </a:pPr>
                      <a:endParaRPr lang="ja-JP" altLang="en-US" sz="12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5228852"/>
                  </a:ext>
                </a:extLst>
              </a:tr>
              <a:tr h="2426516">
                <a:tc>
                  <a:txBody>
                    <a:bodyPr/>
                    <a:lstStyle/>
                    <a:p>
                      <a:pPr algn="l" fontAlgn="ctr">
                        <a:lnSpc>
                          <a:spcPct val="120000"/>
                        </a:lnSpc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20000"/>
                        </a:lnSpc>
                      </a:pPr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; Communication, partnership and teamwork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lnSpc>
                          <a:spcPct val="120000"/>
                        </a:lnSpc>
                        <a:buFont typeface="Arial" panose="020B0604020202020204" pitchFamily="34" charset="0"/>
                        <a:buChar char="•"/>
                      </a:pPr>
                      <a:r>
                        <a:rPr kumimoji="1" lang="en-GB" altLang="ja-JP" sz="12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reat patients as individuals and respect their dignity.</a:t>
                      </a:r>
                      <a:endParaRPr kumimoji="1" lang="ja-JP" altLang="ja-JP" sz="1200" b="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171450" indent="9525">
                        <a:lnSpc>
                          <a:spcPct val="120000"/>
                        </a:lnSpc>
                        <a:buFont typeface="Wingdings" panose="05000000000000000000" pitchFamily="2" charset="2"/>
                        <a:buChar char="Ø"/>
                      </a:pPr>
                      <a:r>
                        <a:rPr kumimoji="1" lang="en-GB" altLang="ja-JP" sz="12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reat patients politely and considerately.</a:t>
                      </a:r>
                      <a:endParaRPr kumimoji="1" lang="ja-JP" altLang="ja-JP" sz="1200" b="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171450" indent="9525">
                        <a:lnSpc>
                          <a:spcPct val="120000"/>
                        </a:lnSpc>
                        <a:buFont typeface="Wingdings" panose="05000000000000000000" pitchFamily="2" charset="2"/>
                        <a:buChar char="Ø"/>
                      </a:pPr>
                      <a:r>
                        <a:rPr kumimoji="1" lang="en-GB" altLang="ja-JP" sz="12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espect patients’ right to confidentiality.</a:t>
                      </a:r>
                      <a:endParaRPr kumimoji="1" lang="ja-JP" altLang="ja-JP" sz="1200" b="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171450" indent="-171450">
                        <a:lnSpc>
                          <a:spcPct val="120000"/>
                        </a:lnSpc>
                        <a:buFont typeface="Arial" panose="020B0604020202020204" pitchFamily="34" charset="0"/>
                        <a:buChar char="•"/>
                      </a:pPr>
                      <a:r>
                        <a:rPr kumimoji="1" lang="en-GB" altLang="ja-JP" sz="12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ork in partnership with patients.</a:t>
                      </a:r>
                      <a:endParaRPr kumimoji="1" lang="ja-JP" altLang="ja-JP" sz="1200" b="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171450" indent="9525">
                        <a:lnSpc>
                          <a:spcPct val="120000"/>
                        </a:lnSpc>
                        <a:buFont typeface="Wingdings" panose="05000000000000000000" pitchFamily="2" charset="2"/>
                        <a:buChar char="Ø"/>
                      </a:pPr>
                      <a:r>
                        <a:rPr kumimoji="1" lang="en-GB" altLang="ja-JP" sz="12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isten to, and respond to, their concerns and preferences.</a:t>
                      </a:r>
                      <a:endParaRPr kumimoji="1" lang="ja-JP" altLang="ja-JP" sz="1200" b="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171450" indent="9525">
                        <a:lnSpc>
                          <a:spcPct val="120000"/>
                        </a:lnSpc>
                        <a:buFont typeface="Wingdings" panose="05000000000000000000" pitchFamily="2" charset="2"/>
                        <a:buChar char="Ø"/>
                      </a:pPr>
                      <a:r>
                        <a:rPr kumimoji="1" lang="en-GB" altLang="ja-JP" sz="12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ive patients the information they want or need in a way they can understand.</a:t>
                      </a:r>
                      <a:endParaRPr kumimoji="1" lang="ja-JP" altLang="ja-JP" sz="1200" b="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171450" indent="9525">
                        <a:lnSpc>
                          <a:spcPct val="120000"/>
                        </a:lnSpc>
                        <a:buFont typeface="Wingdings" panose="05000000000000000000" pitchFamily="2" charset="2"/>
                        <a:buChar char="Ø"/>
                      </a:pPr>
                      <a:r>
                        <a:rPr kumimoji="1" lang="en-GB" altLang="ja-JP" sz="12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espect patients’ right to reach decisions with you about their treatment and care.</a:t>
                      </a:r>
                      <a:endParaRPr kumimoji="1" lang="ja-JP" altLang="ja-JP" sz="1200" b="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171450" indent="9525">
                        <a:lnSpc>
                          <a:spcPct val="120000"/>
                        </a:lnSpc>
                        <a:buFont typeface="Wingdings" panose="05000000000000000000" pitchFamily="2" charset="2"/>
                        <a:buChar char="Ø"/>
                      </a:pPr>
                      <a:r>
                        <a:rPr kumimoji="1" lang="en-GB" altLang="ja-JP" sz="12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upport patients in caring for themselves to improve and maintain their health.</a:t>
                      </a:r>
                      <a:endParaRPr kumimoji="1" lang="ja-JP" altLang="ja-JP" sz="1200" b="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171450" indent="-171450">
                        <a:lnSpc>
                          <a:spcPct val="120000"/>
                        </a:lnSpc>
                        <a:buFont typeface="Arial" panose="020B0604020202020204" pitchFamily="34" charset="0"/>
                        <a:buChar char="•"/>
                      </a:pPr>
                      <a:r>
                        <a:rPr kumimoji="1" lang="en-GB" altLang="ja-JP" sz="12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ork with colleagues in the ways that best serve patients’ interests.</a:t>
                      </a:r>
                      <a:endParaRPr kumimoji="1" lang="ja-JP" altLang="ja-JP" sz="1200" b="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20000"/>
                        </a:lnSpc>
                      </a:pPr>
                      <a:endParaRPr lang="ja-JP" altLang="en-US" sz="12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3421201"/>
                  </a:ext>
                </a:extLst>
              </a:tr>
              <a:tr h="970607">
                <a:tc>
                  <a:txBody>
                    <a:bodyPr/>
                    <a:lstStyle/>
                    <a:p>
                      <a:pPr algn="l" fontAlgn="ctr">
                        <a:lnSpc>
                          <a:spcPct val="120000"/>
                        </a:lnSpc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20000"/>
                        </a:lnSpc>
                      </a:pPr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; Maintaining trus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lnSpc>
                          <a:spcPct val="120000"/>
                        </a:lnSpc>
                        <a:buFont typeface="Arial" panose="020B0604020202020204" pitchFamily="34" charset="0"/>
                        <a:buChar char="•"/>
                      </a:pPr>
                      <a:r>
                        <a:rPr kumimoji="1" lang="ja-JP" altLang="ja-JP" sz="12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GB" altLang="ja-JP" sz="12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Be honest and open and act with integrity.</a:t>
                      </a:r>
                      <a:endParaRPr kumimoji="1" lang="ja-JP" altLang="ja-JP" sz="1200" b="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171450" indent="9525">
                        <a:lnSpc>
                          <a:spcPct val="120000"/>
                        </a:lnSpc>
                        <a:buFont typeface="Wingdings" panose="05000000000000000000" pitchFamily="2" charset="2"/>
                        <a:buChar char="Ø"/>
                      </a:pPr>
                      <a:r>
                        <a:rPr kumimoji="1" lang="en-GB" altLang="ja-JP" sz="12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ever discriminate unfairly against patients or colleagues.</a:t>
                      </a:r>
                      <a:endParaRPr kumimoji="1" lang="ja-JP" altLang="ja-JP" sz="1200" b="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171450" indent="9525">
                        <a:lnSpc>
                          <a:spcPct val="120000"/>
                        </a:lnSpc>
                        <a:buFont typeface="Wingdings" panose="05000000000000000000" pitchFamily="2" charset="2"/>
                        <a:buChar char="Ø"/>
                      </a:pPr>
                      <a:r>
                        <a:rPr kumimoji="1" lang="en-GB" altLang="ja-JP" sz="12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ever abuse your patients’ trust in you or the public’s trust in the profession.</a:t>
                      </a:r>
                    </a:p>
                    <a:p>
                      <a:pPr>
                        <a:lnSpc>
                          <a:spcPct val="120000"/>
                        </a:lnSpc>
                      </a:pPr>
                      <a:endParaRPr lang="ja-JP" altLang="en-US" sz="12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137846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905693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FBEB507-D47D-4372-82E9-B059B3D5EA99}"/>
              </a:ext>
            </a:extLst>
          </p:cNvPr>
          <p:cNvSpPr txBox="1"/>
          <p:nvPr/>
        </p:nvSpPr>
        <p:spPr>
          <a:xfrm>
            <a:off x="0" y="156411"/>
            <a:ext cx="1146499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upplementary 3. General Medical Council for graduates 2018 [45]</a:t>
            </a:r>
            <a:endParaRPr lang="ja-JP" altLang="ja-JP" dirty="0"/>
          </a:p>
          <a:p>
            <a:r>
              <a:rPr lang="en-US" altLang="ja-JP" u="sng" dirty="0">
                <a:hlinkClick r:id="rId2"/>
              </a:rPr>
              <a:t>https://www.gmc-uk.org/-/media/documents/dc11326-outcomes-for-graduates-2018_pdf-75040796.pdf</a:t>
            </a:r>
            <a:r>
              <a:rPr lang="en-US" altLang="ja-JP" dirty="0"/>
              <a:t> </a:t>
            </a:r>
            <a:endParaRPr lang="ja-JP" altLang="ja-JP" dirty="0"/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372ECA20-8670-462D-A7FB-A6F6CFC8963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50864553"/>
              </p:ext>
            </p:extLst>
          </p:nvPr>
        </p:nvGraphicFramePr>
        <p:xfrm>
          <a:off x="363297" y="1164889"/>
          <a:ext cx="11465405" cy="501332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73108">
                  <a:extLst>
                    <a:ext uri="{9D8B030D-6E8A-4147-A177-3AD203B41FA5}">
                      <a16:colId xmlns:a16="http://schemas.microsoft.com/office/drawing/2014/main" val="3916107672"/>
                    </a:ext>
                  </a:extLst>
                </a:gridCol>
                <a:gridCol w="3054745">
                  <a:extLst>
                    <a:ext uri="{9D8B030D-6E8A-4147-A177-3AD203B41FA5}">
                      <a16:colId xmlns:a16="http://schemas.microsoft.com/office/drawing/2014/main" val="3104579056"/>
                    </a:ext>
                  </a:extLst>
                </a:gridCol>
                <a:gridCol w="6437552">
                  <a:extLst>
                    <a:ext uri="{9D8B030D-6E8A-4147-A177-3AD203B41FA5}">
                      <a16:colId xmlns:a16="http://schemas.microsoft.com/office/drawing/2014/main" val="3985726344"/>
                    </a:ext>
                  </a:extLst>
                </a:gridCol>
              </a:tblGrid>
              <a:tr h="278091">
                <a:tc grid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ral Medical Council for graduates 2018</a:t>
                      </a:r>
                      <a:endParaRPr lang="ja-JP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5349497"/>
                  </a:ext>
                </a:extLst>
              </a:tr>
              <a:tr h="285785">
                <a:tc>
                  <a:txBody>
                    <a:bodyPr/>
                    <a:lstStyle/>
                    <a:p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ganizer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ral Medical Council, UK</a:t>
                      </a:r>
                    </a:p>
                  </a:txBody>
                  <a:tcPr marL="5060" marR="5060" marT="506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5766287"/>
                  </a:ext>
                </a:extLst>
              </a:tr>
              <a:tr h="1668544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oals / Competencies</a:t>
                      </a:r>
                    </a:p>
                  </a:txBody>
                  <a:tcPr marL="5060" marR="5060" marT="506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; Professional values and behaviors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171450" indent="-171450" algn="l" fontAlgn="ctr">
                        <a:buFont typeface="Arial" panose="020B0604020202020204" pitchFamily="34" charset="0"/>
                        <a:buChar char="•"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rofessional and ethical responsibilities</a:t>
                      </a:r>
                    </a:p>
                    <a:p>
                      <a:pPr marL="171450" indent="-171450" algn="l" fontAlgn="ctr">
                        <a:buFont typeface="Arial" panose="020B0604020202020204" pitchFamily="34" charset="0"/>
                        <a:buChar char="•"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egal responsibilities</a:t>
                      </a:r>
                    </a:p>
                    <a:p>
                      <a:pPr marL="171450" indent="-171450" algn="l" fontAlgn="ctr">
                        <a:buFont typeface="Arial" panose="020B0604020202020204" pitchFamily="34" charset="0"/>
                        <a:buChar char="•"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atient safety and quality improvement</a:t>
                      </a:r>
                    </a:p>
                    <a:p>
                      <a:pPr marL="171450" indent="-171450" algn="l" fontAlgn="ctr">
                        <a:buFont typeface="Arial" panose="020B0604020202020204" pitchFamily="34" charset="0"/>
                        <a:buChar char="•"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ealing with complexity and uncertainty</a:t>
                      </a:r>
                    </a:p>
                    <a:p>
                      <a:pPr marL="171450" indent="-171450" algn="l" fontAlgn="ctr">
                        <a:buFont typeface="Arial" panose="020B0604020202020204" pitchFamily="34" charset="0"/>
                        <a:buChar char="•"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afeguarding vulnerable patients</a:t>
                      </a:r>
                    </a:p>
                    <a:p>
                      <a:pPr marL="171450" marR="0" lvl="0" indent="-17145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eadership and team working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3302942"/>
                  </a:ext>
                </a:extLst>
              </a:tr>
              <a:tr h="1112363"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; Professional skills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171450" indent="-171450" algn="l" fontAlgn="ctr">
                        <a:buFont typeface="Arial" panose="020B0604020202020204" pitchFamily="34" charset="0"/>
                        <a:buChar char="•"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ommunication and interpersonal skills</a:t>
                      </a:r>
                    </a:p>
                    <a:p>
                      <a:pPr marL="171450" indent="-171450" algn="l" fontAlgn="ctr">
                        <a:buFont typeface="Arial" panose="020B0604020202020204" pitchFamily="34" charset="0"/>
                        <a:buChar char="•"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iagnosis and medical management</a:t>
                      </a:r>
                    </a:p>
                    <a:p>
                      <a:pPr marL="171450" indent="-171450" algn="l" fontAlgn="ctr">
                        <a:buFont typeface="Arial" panose="020B0604020202020204" pitchFamily="34" charset="0"/>
                        <a:buChar char="•"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rescribing medicines safely</a:t>
                      </a:r>
                    </a:p>
                    <a:p>
                      <a:pPr marL="171450" marR="0" lvl="0" indent="-17145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Using information effectively and safely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1174887"/>
                  </a:ext>
                </a:extLst>
              </a:tr>
              <a:tr h="1668544"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; Professional knowledge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171450" indent="-171450" algn="l" fontAlgn="ctr">
                        <a:buFont typeface="Arial" panose="020B0604020202020204" pitchFamily="34" charset="0"/>
                        <a:buChar char="•"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he health service and healthcare systems in the four countries</a:t>
                      </a:r>
                    </a:p>
                    <a:p>
                      <a:pPr marL="171450" indent="-171450" algn="l" fontAlgn="ctr">
                        <a:buFont typeface="Arial" panose="020B0604020202020204" pitchFamily="34" charset="0"/>
                        <a:buChar char="•"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pplying biomedical scientific principles</a:t>
                      </a:r>
                    </a:p>
                    <a:p>
                      <a:pPr marL="171450" indent="-171450" algn="l" fontAlgn="ctr">
                        <a:buFont typeface="Arial" panose="020B0604020202020204" pitchFamily="34" charset="0"/>
                        <a:buChar char="•"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pplying psychological principles</a:t>
                      </a:r>
                    </a:p>
                    <a:p>
                      <a:pPr marL="171450" indent="-171450" algn="l" fontAlgn="ctr">
                        <a:buFont typeface="Arial" panose="020B0604020202020204" pitchFamily="34" charset="0"/>
                        <a:buChar char="•"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pplying social science principles</a:t>
                      </a:r>
                    </a:p>
                    <a:p>
                      <a:pPr marL="171450" indent="-171450" algn="l" fontAlgn="ctr">
                        <a:buFont typeface="Arial" panose="020B0604020202020204" pitchFamily="34" charset="0"/>
                        <a:buChar char="•"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ealth promotion and illness prevention</a:t>
                      </a:r>
                    </a:p>
                    <a:p>
                      <a:pPr marL="171450" marR="0" lvl="0" indent="-17145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linical research and scholarship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020482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160544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FBEB507-D47D-4372-82E9-B059B3D5EA99}"/>
              </a:ext>
            </a:extLst>
          </p:cNvPr>
          <p:cNvSpPr txBox="1"/>
          <p:nvPr/>
        </p:nvSpPr>
        <p:spPr>
          <a:xfrm>
            <a:off x="0" y="12032"/>
            <a:ext cx="1239954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upplementary 4. General Medical Council for graduates</a:t>
            </a:r>
            <a:r>
              <a:rPr lang="ja-JP" altLang="ja-JP" b="1" dirty="0"/>
              <a:t>：</a:t>
            </a:r>
            <a:r>
              <a:rPr lang="en-US" altLang="ja-JP" b="1" dirty="0"/>
              <a:t>Practical skills and procedures-practical 2019 [46]</a:t>
            </a:r>
            <a:endParaRPr lang="ja-JP" altLang="ja-JP" dirty="0"/>
          </a:p>
          <a:p>
            <a:r>
              <a:rPr lang="en-US" altLang="ja-JP" u="sng" dirty="0">
                <a:hlinkClick r:id="rId2"/>
              </a:rPr>
              <a:t>https://www.gmc-uk.org/-/media/documents/practical-skills-and-procedures-a4_pdf-78058950.pdf</a:t>
            </a:r>
            <a:endParaRPr kumimoji="1" lang="ja-JP" altLang="en-US" sz="1200" b="1" dirty="0"/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372ECA20-8670-462D-A7FB-A6F6CFC8963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23086738"/>
              </p:ext>
            </p:extLst>
          </p:nvPr>
        </p:nvGraphicFramePr>
        <p:xfrm>
          <a:off x="363297" y="815976"/>
          <a:ext cx="11465405" cy="573721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73108">
                  <a:extLst>
                    <a:ext uri="{9D8B030D-6E8A-4147-A177-3AD203B41FA5}">
                      <a16:colId xmlns:a16="http://schemas.microsoft.com/office/drawing/2014/main" val="3916107672"/>
                    </a:ext>
                  </a:extLst>
                </a:gridCol>
                <a:gridCol w="2560060">
                  <a:extLst>
                    <a:ext uri="{9D8B030D-6E8A-4147-A177-3AD203B41FA5}">
                      <a16:colId xmlns:a16="http://schemas.microsoft.com/office/drawing/2014/main" val="3104579056"/>
                    </a:ext>
                  </a:extLst>
                </a:gridCol>
                <a:gridCol w="6932237">
                  <a:extLst>
                    <a:ext uri="{9D8B030D-6E8A-4147-A177-3AD203B41FA5}">
                      <a16:colId xmlns:a16="http://schemas.microsoft.com/office/drawing/2014/main" val="3985726344"/>
                    </a:ext>
                  </a:extLst>
                </a:gridCol>
              </a:tblGrid>
              <a:tr h="223551">
                <a:tc gridSpan="3">
                  <a:txBody>
                    <a:bodyPr/>
                    <a:lstStyle/>
                    <a:p>
                      <a:r>
                        <a:rPr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ral Medical Council for graduates</a:t>
                      </a:r>
                      <a:r>
                        <a:rPr lang="ja-JP" altLang="en-US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：</a:t>
                      </a:r>
                      <a:r>
                        <a:rPr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actical skills and procedures</a:t>
                      </a:r>
                      <a:r>
                        <a:rPr lang="ja-JP" altLang="en-US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practical </a:t>
                      </a:r>
                      <a:r>
                        <a:rPr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9</a:t>
                      </a:r>
                      <a:endParaRPr lang="ja-JP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79833491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ganizer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ral Medical Council, UK</a:t>
                      </a:r>
                    </a:p>
                  </a:txBody>
                  <a:tcPr marL="5060" marR="5060" marT="506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3396984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oals / Competencies</a:t>
                      </a: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4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. Assessment of patients need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 Take baseline physiological observations and record appropriately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 Carry out peak expiratory flow respiratory function test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 Perform direct ophthalmoscopy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 Perform otoscopy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54046195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t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69419348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t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5800573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t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7396226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7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i. Diagnostic procedure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7">
                  <a:txBody>
                    <a:bodyPr/>
                    <a:lstStyle/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 Take blood culture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 Carry out arterial blood gas and acid base sampling from the radial artery in adult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 Carry out venipunctur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 Measure capillary blood glucos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 Carry out a urine multi dipstick test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 Carry out a </a:t>
                      </a:r>
                      <a:r>
                        <a:rPr lang="en-US" altLang="ja-JP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- and 12-lead electrocardiogram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 Take and/or instruct patients how to take a swab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712396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t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4926614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t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59076969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t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1941539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t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98241669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t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51262316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t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79144151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. Patient care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 Perform surgical scrubbing up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 Set up an infusio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 Use correct techniques for moving and handling, including patients who are frail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05565931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t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8748223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t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02561082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. Prescribing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 Instruct patients in the use of devices for inhaled medicatio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 Prescribe and administer oxyge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 Prepare and administer injectable (intramuscular, subcutaneous, intravenous) drug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45409341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t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3463166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t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5137843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6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. Therapeutic procedures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6">
                  <a:txBody>
                    <a:bodyPr/>
                    <a:lstStyle/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 Carry out intravenous cannulatio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 Carry out safe and appropriate blood transfusio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 Carry out male and female urinary catheterizatio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 Carry out wound care and basic wound closure and dressing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 Carry out nasogastric tube placement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  <a:p>
                      <a:pPr algn="l" fontAlgn="t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 Use local anesthetic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68041363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t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9357124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t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685319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t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3471223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t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34053259"/>
                  </a:ext>
                </a:extLst>
              </a:tr>
              <a:tr h="22973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 fontAlgn="t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3290281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794328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D1FF2BFB-D3CD-461F-B512-F20F8501E38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06798009"/>
              </p:ext>
            </p:extLst>
          </p:nvPr>
        </p:nvGraphicFramePr>
        <p:xfrm>
          <a:off x="360121" y="740907"/>
          <a:ext cx="11514668" cy="576667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16041">
                  <a:extLst>
                    <a:ext uri="{9D8B030D-6E8A-4147-A177-3AD203B41FA5}">
                      <a16:colId xmlns:a16="http://schemas.microsoft.com/office/drawing/2014/main" val="3585613830"/>
                    </a:ext>
                  </a:extLst>
                </a:gridCol>
                <a:gridCol w="5860404">
                  <a:extLst>
                    <a:ext uri="{9D8B030D-6E8A-4147-A177-3AD203B41FA5}">
                      <a16:colId xmlns:a16="http://schemas.microsoft.com/office/drawing/2014/main" val="518592929"/>
                    </a:ext>
                  </a:extLst>
                </a:gridCol>
                <a:gridCol w="3838223">
                  <a:extLst>
                    <a:ext uri="{9D8B030D-6E8A-4147-A177-3AD203B41FA5}">
                      <a16:colId xmlns:a16="http://schemas.microsoft.com/office/drawing/2014/main" val="46765008"/>
                    </a:ext>
                  </a:extLst>
                </a:gridCol>
              </a:tblGrid>
              <a:tr h="258866">
                <a:tc grid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odel Core Curriculum for Medical Education 2016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385557100"/>
                  </a:ext>
                </a:extLst>
              </a:tr>
              <a:tr h="258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Organizer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Ministry of Education, Culture, Sports, Science and Technology (MEXT), Japan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200" dirty="0"/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5136231"/>
                  </a:ext>
                </a:extLst>
              </a:tr>
              <a:tr h="25886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Objects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Medical Students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6003913"/>
                  </a:ext>
                </a:extLst>
              </a:tr>
              <a:tr h="25886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oals / Competencies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. Basic qualities and abilities required of a physician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+mj-lt"/>
                        <a:buNone/>
                        <a:tabLst/>
                        <a:defRPr/>
                      </a:pP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-1.Professionalism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7725351"/>
                  </a:ext>
                </a:extLst>
              </a:tr>
              <a:tr h="258866"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indent="0" algn="l" fontAlgn="ctr">
                        <a:buFont typeface="+mj-lt"/>
                        <a:buNone/>
                      </a:pPr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-2. Medical knowledge and problem-solving skills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5228852"/>
                  </a:ext>
                </a:extLst>
              </a:tr>
              <a:tr h="258866"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-3. Clinical Skills and Patient Care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3421201"/>
                  </a:ext>
                </a:extLst>
              </a:tr>
              <a:tr h="258866"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-4. Communication skill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1378466"/>
                  </a:ext>
                </a:extLst>
              </a:tr>
              <a:tr h="258866"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-5. Practice of team medici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1875678"/>
                  </a:ext>
                </a:extLst>
              </a:tr>
              <a:tr h="258866"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-6. Quality and Safety Management of Medical Car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2477982"/>
                  </a:ext>
                </a:extLst>
              </a:tr>
              <a:tr h="258866"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-7. Practicing medicine in societ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3920332"/>
                  </a:ext>
                </a:extLst>
              </a:tr>
              <a:tr h="258866"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-8. Scientific Inquir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8376964"/>
                  </a:ext>
                </a:extLst>
              </a:tr>
              <a:tr h="258866"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-9. A lifelong commitment to learning togethe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2021167"/>
                  </a:ext>
                </a:extLst>
              </a:tr>
              <a:tr h="266028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. Society and Medicine</a:t>
                      </a: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indent="0" algn="l" fontAlgn="b">
                        <a:buNone/>
                      </a:pP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07728304"/>
                  </a:ext>
                </a:extLst>
              </a:tr>
              <a:tr h="266028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. Basic Medicine and Behavior science</a:t>
                      </a: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8971869"/>
                  </a:ext>
                </a:extLst>
              </a:tr>
              <a:tr h="266028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D. Structure and function 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of human organ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, pathology, diagnosis and treatment</a:t>
                      </a: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56064278"/>
                  </a:ext>
                </a:extLst>
              </a:tr>
              <a:tr h="266028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E. Systemic physiological changes, pathogenesis, diagnosis, and treatment</a:t>
                      </a: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8044532"/>
                  </a:ext>
                </a:extLst>
              </a:tr>
              <a:tr h="266028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. Basics of Medical Care</a:t>
                      </a: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F-1. Approaches from symptom and pathology</a:t>
                      </a: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8176854"/>
                  </a:ext>
                </a:extLst>
              </a:tr>
              <a:tr h="266028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F-2. Basic medical knowledge</a:t>
                      </a: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99623737"/>
                  </a:ext>
                </a:extLst>
              </a:tr>
              <a:tr h="266028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F-3. Basic Medical Skills</a:t>
                      </a: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097029"/>
                  </a:ext>
                </a:extLst>
              </a:tr>
              <a:tr h="266028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. Clinical Clerkship</a:t>
                      </a: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G-1. Basics of Medical Care</a:t>
                      </a: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2186132"/>
                  </a:ext>
                </a:extLst>
              </a:tr>
              <a:tr h="266028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G-2. Clinical Reasoning</a:t>
                      </a: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63481771"/>
                  </a:ext>
                </a:extLst>
              </a:tr>
              <a:tr h="266028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G-3. Basic clinical skills</a:t>
                      </a:r>
                    </a:p>
                  </a:txBody>
                  <a:tcPr marL="5060" marR="5060" marT="506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2113370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EE68331-7FBC-4C3B-9782-9680CD048C25}"/>
              </a:ext>
            </a:extLst>
          </p:cNvPr>
          <p:cNvSpPr txBox="1"/>
          <p:nvPr/>
        </p:nvSpPr>
        <p:spPr>
          <a:xfrm>
            <a:off x="17057" y="0"/>
            <a:ext cx="1217673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upplementary 5. Model Core Curriculum for Medical Education in Japan 2016 [47]</a:t>
            </a:r>
            <a:endParaRPr lang="ja-JP" altLang="ja-JP" dirty="0"/>
          </a:p>
          <a:p>
            <a:r>
              <a:rPr lang="en-US" altLang="ja-JP" u="sng" dirty="0">
                <a:hlinkClick r:id="rId3"/>
              </a:rPr>
              <a:t>https://www.mext.go.jp/component/a_menu/education/detail/__icsFiles/afieldfile/2018/06/18/1325989_30.pdf</a:t>
            </a:r>
            <a:endParaRPr kumimoji="1" lang="ja-JP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3556078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D1FF2BFB-D3CD-461F-B512-F20F8501E38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81478735"/>
              </p:ext>
            </p:extLst>
          </p:nvPr>
        </p:nvGraphicFramePr>
        <p:xfrm>
          <a:off x="396217" y="728874"/>
          <a:ext cx="11514669" cy="574917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510765">
                  <a:extLst>
                    <a:ext uri="{9D8B030D-6E8A-4147-A177-3AD203B41FA5}">
                      <a16:colId xmlns:a16="http://schemas.microsoft.com/office/drawing/2014/main" val="3585613830"/>
                    </a:ext>
                  </a:extLst>
                </a:gridCol>
                <a:gridCol w="4165681">
                  <a:extLst>
                    <a:ext uri="{9D8B030D-6E8A-4147-A177-3AD203B41FA5}">
                      <a16:colId xmlns:a16="http://schemas.microsoft.com/office/drawing/2014/main" val="518592929"/>
                    </a:ext>
                  </a:extLst>
                </a:gridCol>
                <a:gridCol w="3838223">
                  <a:extLst>
                    <a:ext uri="{9D8B030D-6E8A-4147-A177-3AD203B41FA5}">
                      <a16:colId xmlns:a16="http://schemas.microsoft.com/office/drawing/2014/main" val="46765008"/>
                    </a:ext>
                  </a:extLst>
                </a:gridCol>
              </a:tblGrid>
              <a:tr h="280096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asic qualities and abilities required of a physician 2020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631848884"/>
                  </a:ext>
                </a:extLst>
              </a:tr>
              <a:tr h="287846">
                <a:tc>
                  <a:txBody>
                    <a:bodyPr/>
                    <a:lstStyle/>
                    <a:p>
                      <a:r>
                        <a:rPr lang="en-US" altLang="ja-JP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ganizer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istry of Health, </a:t>
                      </a:r>
                      <a:r>
                        <a:rPr lang="en-US" altLang="ja-JP" sz="12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bour</a:t>
                      </a:r>
                      <a:r>
                        <a:rPr lang="en-US" altLang="ja-JP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d Welfare (MHLW), Japan</a:t>
                      </a:r>
                      <a:endParaRPr lang="ja-JP" altLang="en-US" sz="12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200" dirty="0"/>
                    </a:p>
                  </a:txBody>
                  <a:tcPr marL="5060" marR="5060" marT="506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69029122"/>
                  </a:ext>
                </a:extLst>
              </a:tr>
              <a:tr h="2878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Objects</a:t>
                      </a: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Residents</a:t>
                      </a: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200"/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2887646"/>
                  </a:ext>
                </a:extLst>
              </a:tr>
              <a:tr h="28784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oals / Competencies</a:t>
                      </a: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A. Fundamental Values as Physicians (Professionalism)</a:t>
                      </a: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indent="0" algn="l" fontAlgn="b">
                        <a:buNone/>
                      </a:pPr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</a:t>
                      </a:r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ountabilit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07728304"/>
                  </a:ext>
                </a:extLst>
              </a:tr>
              <a:tr h="28784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 Altruistic Attitud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8971869"/>
                  </a:ext>
                </a:extLst>
              </a:tr>
              <a:tr h="28784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 Respect for Humanit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56064278"/>
                  </a:ext>
                </a:extLst>
              </a:tr>
              <a:tr h="28784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 Lifelong Learnin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8044532"/>
                  </a:ext>
                </a:extLst>
              </a:tr>
              <a:tr h="28784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 Competencies and Capabilities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 Ethics in Medicine and Medical Practic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8176854"/>
                  </a:ext>
                </a:extLst>
              </a:tr>
              <a:tr h="28784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 Medical Knowledge and Problem-solvin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99623737"/>
                  </a:ext>
                </a:extLst>
              </a:tr>
              <a:tr h="28784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 Procedural Skills and Patient Car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097029"/>
                  </a:ext>
                </a:extLst>
              </a:tr>
              <a:tr h="28784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 Interpersonal and Communication Skill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2186132"/>
                  </a:ext>
                </a:extLst>
              </a:tr>
              <a:tr h="28784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 Practice in Interprofessional Team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63481771"/>
                  </a:ext>
                </a:extLst>
              </a:tr>
              <a:tr h="28784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 Patient Safety and Quality of Medical Car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2113370"/>
                  </a:ext>
                </a:extLst>
              </a:tr>
              <a:tr h="28784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 Medical Practice in the Context of Societ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3575201"/>
                  </a:ext>
                </a:extLst>
              </a:tr>
              <a:tr h="28784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 Scientific Explora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2385389"/>
                  </a:ext>
                </a:extLst>
              </a:tr>
              <a:tr h="28784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 Lifelong Learnin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9967868"/>
                  </a:ext>
                </a:extLst>
              </a:tr>
              <a:tr h="28784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 Independent Practice Allowed in Conditional Situations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 General Ambulatory Car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163097"/>
                  </a:ext>
                </a:extLst>
              </a:tr>
              <a:tr h="28784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 Ward Car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9490157"/>
                  </a:ext>
                </a:extLst>
              </a:tr>
              <a:tr h="28784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 Primary Emergency Car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4332820"/>
                  </a:ext>
                </a:extLst>
              </a:tr>
              <a:tr h="287846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 Community Medici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060" marR="5060" marT="506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3865267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EE68331-7FBC-4C3B-9782-9680CD048C25}"/>
              </a:ext>
            </a:extLst>
          </p:cNvPr>
          <p:cNvSpPr txBox="1"/>
          <p:nvPr/>
        </p:nvSpPr>
        <p:spPr>
          <a:xfrm>
            <a:off x="0" y="-49805"/>
            <a:ext cx="904125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upplementary 6. Basic qualities and abilities required of a physician 2020 [48]</a:t>
            </a:r>
            <a:endParaRPr lang="ja-JP" altLang="ja-JP" dirty="0"/>
          </a:p>
          <a:p>
            <a:r>
              <a:rPr lang="en-US" altLang="ja-JP" u="sng" dirty="0">
                <a:hlinkClick r:id="rId3"/>
              </a:rPr>
              <a:t>https://www.mhlw.go.jp/content/10800000/000719078.pdf</a:t>
            </a:r>
            <a:endParaRPr kumimoji="1" lang="ja-JP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7356320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表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61054636"/>
              </p:ext>
            </p:extLst>
          </p:nvPr>
        </p:nvGraphicFramePr>
        <p:xfrm>
          <a:off x="377953" y="758592"/>
          <a:ext cx="11484865" cy="5874249"/>
        </p:xfrm>
        <a:graphic>
          <a:graphicData uri="http://schemas.openxmlformats.org/drawingml/2006/table">
            <a:tbl>
              <a:tblPr/>
              <a:tblGrid>
                <a:gridCol w="309688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9989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9989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9989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9989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9989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99989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99989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388738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366804">
                <a:tc gridSpan="3">
                  <a:txBody>
                    <a:bodyPr/>
                    <a:lstStyle/>
                    <a:p>
                      <a:pPr algn="l" fontAlgn="t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edical professional evaluation scale</a:t>
                      </a:r>
                    </a:p>
                  </a:txBody>
                  <a:tcPr marL="7745" marR="7745" marT="77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8438"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1445">
                <a:tc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actor name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tem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8438"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66804">
                <a:tc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actor 1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8"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 have built a relationship of mutual aid and cooperation with colleagues within my profession.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72673">
                <a:tc>
                  <a:txBody>
                    <a:bodyPr/>
                    <a:lstStyle/>
                    <a:p>
                      <a:pPr algn="l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ollaboration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8"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 can discuss the state of treatment and care with colleagues in the same profession </a:t>
                      </a:r>
                      <a:b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</a:b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ith both more or equal amount of experience as myself.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1373"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7"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 want to actively participate in the guidance or education of my juniors.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66804"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8"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 understand the knowledge, skills, and specializations of other professionals to consult </a:t>
                      </a:r>
                      <a:b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</a:b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hem appropriately.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8438"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1373">
                <a:tc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actor 2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8"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 can plan treatment and care strategies considering the patient's quality of life.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01445">
                <a:tc>
                  <a:txBody>
                    <a:bodyPr/>
                    <a:lstStyle/>
                    <a:p>
                      <a:pPr algn="l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oviding safe, quality care 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8"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 understand the basic principles of safety management in providing treatment and care.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91373"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7"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 know the standard treatments and care methods for common diseases.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66804"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7"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 can explain things to patients accurately in a way that is easy to understand.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91373"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8"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 can provide the necessary information required by patients for decision making.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91373"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 understand the intent and purpose of a second opinion.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88438"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91373">
                <a:tc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actor 3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6"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 can accurately estimate my current capacity and limits.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01445">
                <a:tc>
                  <a:txBody>
                    <a:bodyPr/>
                    <a:lstStyle/>
                    <a:p>
                      <a:pPr algn="l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flective practice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 am open to criticism or assessment by others.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91373"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8"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 report or can report my mistakes or errors to my instructor without hiding them.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91373"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8"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 can look back on my mistakes to analyze their cause and benefit from them in future.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88438"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372673">
                <a:tc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actor 4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8"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 have knowledge on the medical or public health activities and welfare services being </a:t>
                      </a:r>
                      <a:b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</a:b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ffered in accordance with the characteristics of the community.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366804">
                <a:tc>
                  <a:txBody>
                    <a:bodyPr/>
                    <a:lstStyle/>
                    <a:p>
                      <a:pPr algn="l" fontAlgn="t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nterest in community health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8"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 know the functions and roles of professionals working in public health, medical, and </a:t>
                      </a:r>
                      <a:b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</a:b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elfare facilities other than hospitals.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91373"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 can describe my specialization or activities to a layperson.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7745" marR="7745" marT="774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87CF770-A36A-4EE0-B408-1DE2CC3E7529}"/>
              </a:ext>
            </a:extLst>
          </p:cNvPr>
          <p:cNvSpPr txBox="1"/>
          <p:nvPr/>
        </p:nvSpPr>
        <p:spPr>
          <a:xfrm>
            <a:off x="-2485" y="0"/>
            <a:ext cx="696056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upplementary 7. Medical professional evaluation scale [49]</a:t>
            </a:r>
            <a:endParaRPr lang="ja-JP" altLang="ja-JP" dirty="0"/>
          </a:p>
          <a:p>
            <a:r>
              <a:rPr lang="en-US" altLang="ja-JP" u="sng" dirty="0">
                <a:hlinkClick r:id="rId2"/>
              </a:rPr>
              <a:t>https://mededpublish.org/articles/8-91</a:t>
            </a:r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25959853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78</TotalTime>
  <Words>1568</Words>
  <Application>Microsoft Office PowerPoint</Application>
  <PresentationFormat>ワイド画面</PresentationFormat>
  <Paragraphs>237</Paragraphs>
  <Slides>7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3" baseType="lpstr">
      <vt:lpstr>新細明體</vt:lpstr>
      <vt:lpstr>游ゴシック</vt:lpstr>
      <vt:lpstr>游ゴシック Light</vt:lpstr>
      <vt:lpstr>Arial</vt:lpstr>
      <vt:lpstr>Wingdings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hisa Tsuji</dc:creator>
  <cp:lastModifiedBy>Yoshihisa Tsuji</cp:lastModifiedBy>
  <cp:revision>144</cp:revision>
  <cp:lastPrinted>2022-06-24T06:09:25Z</cp:lastPrinted>
  <dcterms:created xsi:type="dcterms:W3CDTF">2021-10-01T02:26:44Z</dcterms:created>
  <dcterms:modified xsi:type="dcterms:W3CDTF">2022-09-26T11:45:28Z</dcterms:modified>
</cp:coreProperties>
</file>